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2307087-8709-4709-9FDA-007B3E081FC4}" v="10" dt="2026-04-19T17:54:45.836"/>
    <p1510:client id="{83078761-7618-489B-8217-392B1E47D7F7}" v="5" dt="2026-04-20T11:52:31.94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25" autoAdjust="0"/>
    <p:restoredTop sz="94660"/>
  </p:normalViewPr>
  <p:slideViewPr>
    <p:cSldViewPr snapToGrid="0">
      <p:cViewPr varScale="1">
        <p:scale>
          <a:sx n="68" d="100"/>
          <a:sy n="68" d="100"/>
        </p:scale>
        <p:origin x="48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anne, Isabelle" userId="68246d2c-cea7-41e5-ae68-061af3e0a041" providerId="ADAL" clId="{E5DDC2F5-41B0-4C65-A84B-E802C2363F07}"/>
    <pc:docChg chg="undo custSel modSld">
      <pc:chgData name="Panne, Isabelle" userId="68246d2c-cea7-41e5-ae68-061af3e0a041" providerId="ADAL" clId="{E5DDC2F5-41B0-4C65-A84B-E802C2363F07}" dt="2026-04-20T11:52:53.411" v="109" actId="20577"/>
      <pc:docMkLst>
        <pc:docMk/>
      </pc:docMkLst>
      <pc:sldChg chg="addSp delSp modSp mod">
        <pc:chgData name="Panne, Isabelle" userId="68246d2c-cea7-41e5-ae68-061af3e0a041" providerId="ADAL" clId="{E5DDC2F5-41B0-4C65-A84B-E802C2363F07}" dt="2026-04-20T11:52:53.411" v="109" actId="20577"/>
        <pc:sldMkLst>
          <pc:docMk/>
          <pc:sldMk cId="581619952" sldId="256"/>
        </pc:sldMkLst>
        <pc:spChg chg="mod">
          <ac:chgData name="Panne, Isabelle" userId="68246d2c-cea7-41e5-ae68-061af3e0a041" providerId="ADAL" clId="{E5DDC2F5-41B0-4C65-A84B-E802C2363F07}" dt="2026-04-20T11:52:53.411" v="109" actId="20577"/>
          <ac:spMkLst>
            <pc:docMk/>
            <pc:sldMk cId="581619952" sldId="256"/>
            <ac:spMk id="3" creationId="{F9A1ABF8-01A0-9FEC-5A40-10257788CE03}"/>
          </ac:spMkLst>
        </pc:spChg>
        <pc:spChg chg="del mod">
          <ac:chgData name="Panne, Isabelle" userId="68246d2c-cea7-41e5-ae68-061af3e0a041" providerId="ADAL" clId="{E5DDC2F5-41B0-4C65-A84B-E802C2363F07}" dt="2026-04-20T11:52:02.354" v="93" actId="478"/>
          <ac:spMkLst>
            <pc:docMk/>
            <pc:sldMk cId="581619952" sldId="256"/>
            <ac:spMk id="7" creationId="{E6254BCA-EB45-A999-A2EB-9F1304321D2B}"/>
          </ac:spMkLst>
        </pc:spChg>
        <pc:spChg chg="mod">
          <ac:chgData name="Panne, Isabelle" userId="68246d2c-cea7-41e5-ae68-061af3e0a041" providerId="ADAL" clId="{E5DDC2F5-41B0-4C65-A84B-E802C2363F07}" dt="2026-04-20T11:52:46.980" v="107" actId="1076"/>
          <ac:spMkLst>
            <pc:docMk/>
            <pc:sldMk cId="581619952" sldId="256"/>
            <ac:spMk id="8" creationId="{8121643D-01E6-931A-3556-39085837EEA7}"/>
          </ac:spMkLst>
        </pc:spChg>
        <pc:spChg chg="add mod">
          <ac:chgData name="Panne, Isabelle" userId="68246d2c-cea7-41e5-ae68-061af3e0a041" providerId="ADAL" clId="{E5DDC2F5-41B0-4C65-A84B-E802C2363F07}" dt="2026-04-12T13:25:24.599" v="2" actId="113"/>
          <ac:spMkLst>
            <pc:docMk/>
            <pc:sldMk cId="581619952" sldId="256"/>
            <ac:spMk id="9" creationId="{5834878C-4A3A-273D-D262-59FA1FCB5424}"/>
          </ac:spMkLst>
        </pc:spChg>
        <pc:spChg chg="add mod">
          <ac:chgData name="Panne, Isabelle" userId="68246d2c-cea7-41e5-ae68-061af3e0a041" providerId="ADAL" clId="{E5DDC2F5-41B0-4C65-A84B-E802C2363F07}" dt="2026-04-20T11:48:22.871" v="80" actId="1076"/>
          <ac:spMkLst>
            <pc:docMk/>
            <pc:sldMk cId="581619952" sldId="256"/>
            <ac:spMk id="10" creationId="{A7B98BD6-4A33-5A7D-3C8F-AC37582B46CD}"/>
          </ac:spMkLst>
        </pc:spChg>
        <pc:spChg chg="mod">
          <ac:chgData name="Panne, Isabelle" userId="68246d2c-cea7-41e5-ae68-061af3e0a041" providerId="ADAL" clId="{E5DDC2F5-41B0-4C65-A84B-E802C2363F07}" dt="2026-04-20T11:52:51.602" v="108" actId="1076"/>
          <ac:spMkLst>
            <pc:docMk/>
            <pc:sldMk cId="581619952" sldId="256"/>
            <ac:spMk id="12" creationId="{3DD33FB5-F71E-562A-737E-78BD2A7C7C5A}"/>
          </ac:spMkLst>
        </pc:spChg>
        <pc:graphicFrameChg chg="add del mod">
          <ac:chgData name="Panne, Isabelle" userId="68246d2c-cea7-41e5-ae68-061af3e0a041" providerId="ADAL" clId="{E5DDC2F5-41B0-4C65-A84B-E802C2363F07}" dt="2026-04-20T11:52:00.327" v="92" actId="478"/>
          <ac:graphicFrameMkLst>
            <pc:docMk/>
            <pc:sldMk cId="581619952" sldId="256"/>
            <ac:graphicFrameMk id="2" creationId="{07AB0080-2014-A8C0-6C2C-255EDEE9D70D}"/>
          </ac:graphicFrameMkLst>
        </pc:graphicFrameChg>
        <pc:graphicFrameChg chg="mod">
          <ac:chgData name="Panne, Isabelle" userId="68246d2c-cea7-41e5-ae68-061af3e0a041" providerId="ADAL" clId="{E5DDC2F5-41B0-4C65-A84B-E802C2363F07}" dt="2026-04-20T11:52:43.306" v="106" actId="1076"/>
          <ac:graphicFrameMkLst>
            <pc:docMk/>
            <pc:sldMk cId="581619952" sldId="256"/>
            <ac:graphicFrameMk id="5" creationId="{A291ABCB-1F55-5B04-C541-F337704A516E}"/>
          </ac:graphicFrameMkLst>
        </pc:graphicFrameChg>
        <pc:graphicFrameChg chg="mod">
          <ac:chgData name="Panne, Isabelle" userId="68246d2c-cea7-41e5-ae68-061af3e0a041" providerId="ADAL" clId="{E5DDC2F5-41B0-4C65-A84B-E802C2363F07}" dt="2026-04-20T11:52:37.386" v="104" actId="1076"/>
          <ac:graphicFrameMkLst>
            <pc:docMk/>
            <pc:sldMk cId="581619952" sldId="256"/>
            <ac:graphicFrameMk id="11" creationId="{7BD3B448-66A8-65AC-42D5-9A63AA8BA81E}"/>
          </ac:graphicFrameMkLst>
        </pc:graphicFrameChg>
      </pc:sldChg>
      <pc:sldChg chg="addSp modSp mod">
        <pc:chgData name="Panne, Isabelle" userId="68246d2c-cea7-41e5-ae68-061af3e0a041" providerId="ADAL" clId="{E5DDC2F5-41B0-4C65-A84B-E802C2363F07}" dt="2026-04-12T13:31:21.522" v="72" actId="255"/>
        <pc:sldMkLst>
          <pc:docMk/>
          <pc:sldMk cId="903275470" sldId="257"/>
        </pc:sldMkLst>
      </pc:sldChg>
    </pc:docChg>
  </pc:docChgLst>
  <pc:docChgLst>
    <pc:chgData name="Panne, Isabelle" userId="68246d2c-cea7-41e5-ae68-061af3e0a041" providerId="ADAL" clId="{7F90142C-2691-4CAD-A9FA-FC7E7537B507}"/>
    <pc:docChg chg="undo redo custSel delSld modSld">
      <pc:chgData name="Panne, Isabelle" userId="68246d2c-cea7-41e5-ae68-061af3e0a041" providerId="ADAL" clId="{7F90142C-2691-4CAD-A9FA-FC7E7537B507}" dt="2026-04-19T18:09:06.367" v="53" actId="1076"/>
      <pc:docMkLst>
        <pc:docMk/>
      </pc:docMkLst>
      <pc:sldChg chg="addSp delSp modSp mod">
        <pc:chgData name="Panne, Isabelle" userId="68246d2c-cea7-41e5-ae68-061af3e0a041" providerId="ADAL" clId="{7F90142C-2691-4CAD-A9FA-FC7E7537B507}" dt="2026-04-19T18:09:06.367" v="53" actId="1076"/>
        <pc:sldMkLst>
          <pc:docMk/>
          <pc:sldMk cId="581619952" sldId="256"/>
        </pc:sldMkLst>
        <pc:spChg chg="add mod">
          <ac:chgData name="Panne, Isabelle" userId="68246d2c-cea7-41e5-ae68-061af3e0a041" providerId="ADAL" clId="{7F90142C-2691-4CAD-A9FA-FC7E7537B507}" dt="2026-04-19T18:08:34.933" v="49" actId="1076"/>
          <ac:spMkLst>
            <pc:docMk/>
            <pc:sldMk cId="581619952" sldId="256"/>
            <ac:spMk id="3" creationId="{F9A1ABF8-01A0-9FEC-5A40-10257788CE03}"/>
          </ac:spMkLst>
        </pc:spChg>
        <pc:spChg chg="add del mod">
          <ac:chgData name="Panne, Isabelle" userId="68246d2c-cea7-41e5-ae68-061af3e0a041" providerId="ADAL" clId="{7F90142C-2691-4CAD-A9FA-FC7E7537B507}" dt="2026-04-19T18:08:08.612" v="45" actId="478"/>
          <ac:spMkLst>
            <pc:docMk/>
            <pc:sldMk cId="581619952" sldId="256"/>
            <ac:spMk id="4" creationId="{1A1CDA78-0FDA-0549-B05B-B9478DED0005}"/>
          </ac:spMkLst>
        </pc:spChg>
        <pc:spChg chg="mod">
          <ac:chgData name="Panne, Isabelle" userId="68246d2c-cea7-41e5-ae68-061af3e0a041" providerId="ADAL" clId="{7F90142C-2691-4CAD-A9FA-FC7E7537B507}" dt="2026-04-19T18:09:06.367" v="53" actId="1076"/>
          <ac:spMkLst>
            <pc:docMk/>
            <pc:sldMk cId="581619952" sldId="256"/>
            <ac:spMk id="6" creationId="{D68D9B48-1F0E-9CE8-9568-D4204FF810E7}"/>
          </ac:spMkLst>
        </pc:spChg>
        <pc:spChg chg="mod">
          <ac:chgData name="Panne, Isabelle" userId="68246d2c-cea7-41e5-ae68-061af3e0a041" providerId="ADAL" clId="{7F90142C-2691-4CAD-A9FA-FC7E7537B507}" dt="2026-04-19T18:08:18.106" v="46" actId="14100"/>
          <ac:spMkLst>
            <pc:docMk/>
            <pc:sldMk cId="581619952" sldId="256"/>
            <ac:spMk id="7" creationId="{E6254BCA-EB45-A999-A2EB-9F1304321D2B}"/>
          </ac:spMkLst>
        </pc:spChg>
        <pc:spChg chg="mod">
          <ac:chgData name="Panne, Isabelle" userId="68246d2c-cea7-41e5-ae68-061af3e0a041" providerId="ADAL" clId="{7F90142C-2691-4CAD-A9FA-FC7E7537B507}" dt="2026-04-19T18:08:21.569" v="47" actId="14100"/>
          <ac:spMkLst>
            <pc:docMk/>
            <pc:sldMk cId="581619952" sldId="256"/>
            <ac:spMk id="8" creationId="{8121643D-01E6-931A-3556-39085837EEA7}"/>
          </ac:spMkLst>
        </pc:spChg>
        <pc:spChg chg="mod">
          <ac:chgData name="Panne, Isabelle" userId="68246d2c-cea7-41e5-ae68-061af3e0a041" providerId="ADAL" clId="{7F90142C-2691-4CAD-A9FA-FC7E7537B507}" dt="2026-04-19T17:51:12.679" v="11" actId="1076"/>
          <ac:spMkLst>
            <pc:docMk/>
            <pc:sldMk cId="581619952" sldId="256"/>
            <ac:spMk id="9" creationId="{5834878C-4A3A-273D-D262-59FA1FCB5424}"/>
          </ac:spMkLst>
        </pc:spChg>
        <pc:spChg chg="mod">
          <ac:chgData name="Panne, Isabelle" userId="68246d2c-cea7-41e5-ae68-061af3e0a041" providerId="ADAL" clId="{7F90142C-2691-4CAD-A9FA-FC7E7537B507}" dt="2026-04-19T17:52:15.778" v="20" actId="1076"/>
          <ac:spMkLst>
            <pc:docMk/>
            <pc:sldMk cId="581619952" sldId="256"/>
            <ac:spMk id="10" creationId="{A7B98BD6-4A33-5A7D-3C8F-AC37582B46CD}"/>
          </ac:spMkLst>
        </pc:spChg>
        <pc:spChg chg="add mod">
          <ac:chgData name="Panne, Isabelle" userId="68246d2c-cea7-41e5-ae68-061af3e0a041" providerId="ADAL" clId="{7F90142C-2691-4CAD-A9FA-FC7E7537B507}" dt="2026-04-19T18:08:53.228" v="52" actId="1076"/>
          <ac:spMkLst>
            <pc:docMk/>
            <pc:sldMk cId="581619952" sldId="256"/>
            <ac:spMk id="12" creationId="{3DD33FB5-F71E-562A-737E-78BD2A7C7C5A}"/>
          </ac:spMkLst>
        </pc:spChg>
        <pc:graphicFrameChg chg="mod">
          <ac:chgData name="Panne, Isabelle" userId="68246d2c-cea7-41e5-ae68-061af3e0a041" providerId="ADAL" clId="{7F90142C-2691-4CAD-A9FA-FC7E7537B507}" dt="2026-04-19T17:51:41.951" v="16" actId="14100"/>
          <ac:graphicFrameMkLst>
            <pc:docMk/>
            <pc:sldMk cId="581619952" sldId="256"/>
            <ac:graphicFrameMk id="2" creationId="{07AB0080-2014-A8C0-6C2C-255EDEE9D70D}"/>
          </ac:graphicFrameMkLst>
        </pc:graphicFrameChg>
        <pc:graphicFrameChg chg="mod">
          <ac:chgData name="Panne, Isabelle" userId="68246d2c-cea7-41e5-ae68-061af3e0a041" providerId="ADAL" clId="{7F90142C-2691-4CAD-A9FA-FC7E7537B507}" dt="2026-04-19T17:52:29.593" v="23" actId="1076"/>
          <ac:graphicFrameMkLst>
            <pc:docMk/>
            <pc:sldMk cId="581619952" sldId="256"/>
            <ac:graphicFrameMk id="5" creationId="{A291ABCB-1F55-5B04-C541-F337704A516E}"/>
          </ac:graphicFrameMkLst>
        </pc:graphicFrameChg>
        <pc:graphicFrameChg chg="add mod">
          <ac:chgData name="Panne, Isabelle" userId="68246d2c-cea7-41e5-ae68-061af3e0a041" providerId="ADAL" clId="{7F90142C-2691-4CAD-A9FA-FC7E7537B507}" dt="2026-04-19T18:08:29.895" v="48" actId="1076"/>
          <ac:graphicFrameMkLst>
            <pc:docMk/>
            <pc:sldMk cId="581619952" sldId="256"/>
            <ac:graphicFrameMk id="11" creationId="{7BD3B448-66A8-65AC-42D5-9A63AA8BA81E}"/>
          </ac:graphicFrameMkLst>
        </pc:graphicFrameChg>
      </pc:sldChg>
      <pc:sldChg chg="delSp del mod">
        <pc:chgData name="Panne, Isabelle" userId="68246d2c-cea7-41e5-ae68-061af3e0a041" providerId="ADAL" clId="{7F90142C-2691-4CAD-A9FA-FC7E7537B507}" dt="2026-04-19T17:55:14.574" v="43" actId="2696"/>
        <pc:sldMkLst>
          <pc:docMk/>
          <pc:sldMk cId="903275470" sldId="257"/>
        </pc:sldMkLst>
        <pc:spChg chg="del">
          <ac:chgData name="Panne, Isabelle" userId="68246d2c-cea7-41e5-ae68-061af3e0a041" providerId="ADAL" clId="{7F90142C-2691-4CAD-A9FA-FC7E7537B507}" dt="2026-04-19T17:52:55.568" v="26" actId="21"/>
          <ac:spMkLst>
            <pc:docMk/>
            <pc:sldMk cId="903275470" sldId="257"/>
            <ac:spMk id="4" creationId="{1A1CDA78-0FDA-0549-B05B-B9478DED0005}"/>
          </ac:spMkLst>
        </pc:spChg>
        <pc:graphicFrameChg chg="del">
          <ac:chgData name="Panne, Isabelle" userId="68246d2c-cea7-41e5-ae68-061af3e0a041" providerId="ADAL" clId="{7F90142C-2691-4CAD-A9FA-FC7E7537B507}" dt="2026-04-19T17:53:41.470" v="30" actId="21"/>
          <ac:graphicFrameMkLst>
            <pc:docMk/>
            <pc:sldMk cId="903275470" sldId="257"/>
            <ac:graphicFrameMk id="2" creationId="{7BD3B448-66A8-65AC-42D5-9A63AA8BA81E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clarunis-my.sharepoint.com/personal/isabelle_panne_clarunis_ch/Documents/CaseReportPaiano/Frontiers/Unterlagen%20f&#252;r%20Review/Laborwerte%20tabellarisch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clarunis-my.sharepoint.com/personal/isabelle_panne_clarunis_ch/Documents/CaseReportPaiano/Frontiers/Unterlagen%20f&#252;r%20Review/Laborwerte%20tabellarisch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CH" b="1" dirty="0"/>
              <a:t>CRP Evolutio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Tabelle2!$B$1</c:f>
              <c:strCache>
                <c:ptCount val="1"/>
                <c:pt idx="0">
                  <c:v>CRP (mg/l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Tabelle2!$A$2:$A$29</c:f>
              <c:numCache>
                <c:formatCode>General</c:formatCode>
                <c:ptCount val="2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</c:numCache>
            </c:numRef>
          </c:cat>
          <c:val>
            <c:numRef>
              <c:f>Tabelle2!$B$2:$B$29</c:f>
              <c:numCache>
                <c:formatCode>General</c:formatCode>
                <c:ptCount val="28"/>
                <c:pt idx="0">
                  <c:v>147</c:v>
                </c:pt>
                <c:pt idx="1">
                  <c:v>124</c:v>
                </c:pt>
                <c:pt idx="2">
                  <c:v>63</c:v>
                </c:pt>
                <c:pt idx="3">
                  <c:v>13.4</c:v>
                </c:pt>
                <c:pt idx="4">
                  <c:v>4.2</c:v>
                </c:pt>
                <c:pt idx="5">
                  <c:v>3.8</c:v>
                </c:pt>
                <c:pt idx="6">
                  <c:v>116</c:v>
                </c:pt>
                <c:pt idx="7">
                  <c:v>59.8</c:v>
                </c:pt>
                <c:pt idx="8">
                  <c:v>81</c:v>
                </c:pt>
                <c:pt idx="9">
                  <c:v>92</c:v>
                </c:pt>
                <c:pt idx="10">
                  <c:v>87.3</c:v>
                </c:pt>
                <c:pt idx="11">
                  <c:v>94.4</c:v>
                </c:pt>
                <c:pt idx="12">
                  <c:v>84.6</c:v>
                </c:pt>
                <c:pt idx="13">
                  <c:v>103.8</c:v>
                </c:pt>
                <c:pt idx="14">
                  <c:v>62.4</c:v>
                </c:pt>
                <c:pt idx="15">
                  <c:v>75</c:v>
                </c:pt>
                <c:pt idx="16">
                  <c:v>1.6</c:v>
                </c:pt>
                <c:pt idx="17">
                  <c:v>1.6</c:v>
                </c:pt>
                <c:pt idx="18">
                  <c:v>2.1</c:v>
                </c:pt>
                <c:pt idx="19">
                  <c:v>2</c:v>
                </c:pt>
                <c:pt idx="20">
                  <c:v>1.5</c:v>
                </c:pt>
                <c:pt idx="21">
                  <c:v>4.5999999999999996</c:v>
                </c:pt>
                <c:pt idx="22">
                  <c:v>36.700000000000003</c:v>
                </c:pt>
                <c:pt idx="23">
                  <c:v>1.1000000000000001</c:v>
                </c:pt>
                <c:pt idx="24">
                  <c:v>3.3</c:v>
                </c:pt>
                <c:pt idx="25">
                  <c:v>2.4</c:v>
                </c:pt>
                <c:pt idx="26">
                  <c:v>4.8</c:v>
                </c:pt>
                <c:pt idx="27">
                  <c:v>5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767-4E47-BE01-2A1C79A4EED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14301872"/>
        <c:axId val="1514314832"/>
      </c:lineChart>
      <c:catAx>
        <c:axId val="15143018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month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514314832"/>
        <c:crosses val="autoZero"/>
        <c:auto val="1"/>
        <c:lblAlgn val="ctr"/>
        <c:lblOffset val="100"/>
        <c:noMultiLvlLbl val="0"/>
      </c:catAx>
      <c:valAx>
        <c:axId val="15143148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mg/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5143018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CH" b="1" dirty="0"/>
              <a:t>GGT/AP Evolutio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Tabelle3!$B$1</c:f>
              <c:strCache>
                <c:ptCount val="1"/>
                <c:pt idx="0">
                  <c:v>gGT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Tabelle3!$A$2:$A$29</c:f>
              <c:numCache>
                <c:formatCode>General</c:formatCode>
                <c:ptCount val="2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</c:numCache>
            </c:numRef>
          </c:cat>
          <c:val>
            <c:numRef>
              <c:f>Tabelle3!$B$2:$B$29</c:f>
              <c:numCache>
                <c:formatCode>General</c:formatCode>
                <c:ptCount val="28"/>
                <c:pt idx="0">
                  <c:v>298</c:v>
                </c:pt>
                <c:pt idx="1">
                  <c:v>414</c:v>
                </c:pt>
                <c:pt idx="2">
                  <c:v>280</c:v>
                </c:pt>
                <c:pt idx="3">
                  <c:v>94</c:v>
                </c:pt>
                <c:pt idx="4">
                  <c:v>41</c:v>
                </c:pt>
                <c:pt idx="5">
                  <c:v>66</c:v>
                </c:pt>
                <c:pt idx="6">
                  <c:v>86</c:v>
                </c:pt>
                <c:pt idx="7">
                  <c:v>65</c:v>
                </c:pt>
                <c:pt idx="8">
                  <c:v>147</c:v>
                </c:pt>
                <c:pt idx="9">
                  <c:v>74</c:v>
                </c:pt>
                <c:pt idx="10">
                  <c:v>113</c:v>
                </c:pt>
                <c:pt idx="11">
                  <c:v>200</c:v>
                </c:pt>
                <c:pt idx="12">
                  <c:v>141</c:v>
                </c:pt>
                <c:pt idx="13">
                  <c:v>99</c:v>
                </c:pt>
                <c:pt idx="14">
                  <c:v>139</c:v>
                </c:pt>
                <c:pt idx="15">
                  <c:v>103</c:v>
                </c:pt>
                <c:pt idx="16">
                  <c:v>97</c:v>
                </c:pt>
                <c:pt idx="17">
                  <c:v>61</c:v>
                </c:pt>
                <c:pt idx="18">
                  <c:v>44</c:v>
                </c:pt>
                <c:pt idx="19">
                  <c:v>45</c:v>
                </c:pt>
                <c:pt idx="20">
                  <c:v>36</c:v>
                </c:pt>
                <c:pt idx="21">
                  <c:v>53</c:v>
                </c:pt>
                <c:pt idx="22">
                  <c:v>50</c:v>
                </c:pt>
                <c:pt idx="23">
                  <c:v>70</c:v>
                </c:pt>
                <c:pt idx="24">
                  <c:v>38</c:v>
                </c:pt>
                <c:pt idx="25">
                  <c:v>41</c:v>
                </c:pt>
                <c:pt idx="26">
                  <c:v>35</c:v>
                </c:pt>
                <c:pt idx="27">
                  <c:v>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4C3-4507-8348-5A668A7C5284}"/>
            </c:ext>
          </c:extLst>
        </c:ser>
        <c:ser>
          <c:idx val="1"/>
          <c:order val="1"/>
          <c:tx>
            <c:strRef>
              <c:f>Tabelle3!$C$1</c:f>
              <c:strCache>
                <c:ptCount val="1"/>
                <c:pt idx="0">
                  <c:v>AP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Tabelle3!$A$2:$A$29</c:f>
              <c:numCache>
                <c:formatCode>General</c:formatCode>
                <c:ptCount val="2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</c:numCache>
            </c:numRef>
          </c:cat>
          <c:val>
            <c:numRef>
              <c:f>Tabelle3!$C$2:$C$29</c:f>
              <c:numCache>
                <c:formatCode>General</c:formatCode>
                <c:ptCount val="28"/>
                <c:pt idx="0">
                  <c:v>219</c:v>
                </c:pt>
                <c:pt idx="1">
                  <c:v>428</c:v>
                </c:pt>
                <c:pt idx="2">
                  <c:v>655</c:v>
                </c:pt>
                <c:pt idx="3">
                  <c:v>135</c:v>
                </c:pt>
                <c:pt idx="4">
                  <c:v>100</c:v>
                </c:pt>
                <c:pt idx="5">
                  <c:v>72</c:v>
                </c:pt>
                <c:pt idx="6">
                  <c:v>58</c:v>
                </c:pt>
                <c:pt idx="7">
                  <c:v>78</c:v>
                </c:pt>
                <c:pt idx="8">
                  <c:v>122</c:v>
                </c:pt>
                <c:pt idx="9">
                  <c:v>94</c:v>
                </c:pt>
                <c:pt idx="10">
                  <c:v>96</c:v>
                </c:pt>
                <c:pt idx="11">
                  <c:v>93</c:v>
                </c:pt>
                <c:pt idx="12">
                  <c:v>119</c:v>
                </c:pt>
                <c:pt idx="13">
                  <c:v>162</c:v>
                </c:pt>
                <c:pt idx="14">
                  <c:v>136</c:v>
                </c:pt>
                <c:pt idx="15">
                  <c:v>128</c:v>
                </c:pt>
                <c:pt idx="16">
                  <c:v>113</c:v>
                </c:pt>
                <c:pt idx="17">
                  <c:v>114</c:v>
                </c:pt>
                <c:pt idx="18">
                  <c:v>76</c:v>
                </c:pt>
                <c:pt idx="19">
                  <c:v>70</c:v>
                </c:pt>
                <c:pt idx="20">
                  <c:v>72</c:v>
                </c:pt>
                <c:pt idx="21">
                  <c:v>84</c:v>
                </c:pt>
                <c:pt idx="22">
                  <c:v>114</c:v>
                </c:pt>
                <c:pt idx="23">
                  <c:v>152</c:v>
                </c:pt>
                <c:pt idx="24">
                  <c:v>74</c:v>
                </c:pt>
                <c:pt idx="25">
                  <c:v>55</c:v>
                </c:pt>
                <c:pt idx="26">
                  <c:v>68</c:v>
                </c:pt>
                <c:pt idx="27">
                  <c:v>5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4C3-4507-8348-5A668A7C52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218330976"/>
        <c:axId val="1510959792"/>
      </c:lineChart>
      <c:catAx>
        <c:axId val="12183309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month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510959792"/>
        <c:crosses val="autoZero"/>
        <c:auto val="1"/>
        <c:lblAlgn val="ctr"/>
        <c:lblOffset val="100"/>
        <c:noMultiLvlLbl val="0"/>
      </c:catAx>
      <c:valAx>
        <c:axId val="15109597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U/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2183309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E9D7A9C-FD51-DC50-F61A-B4072FF57FC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41703D7E-0C3A-F967-EC41-9D8613BB7B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C4E3951-E223-4B17-80CB-265FE7CF88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BC52F-5867-487E-8BB6-EC98DC89B367}" type="datetimeFigureOut">
              <a:rPr lang="de-CH" smtClean="0"/>
              <a:t>10.06.2026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A247D29-56D5-B09A-E9DE-051CAE02BA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933DB41-3D71-906A-4171-E3B247C110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9D2DF-16F7-4C7C-B84D-897D9BA3B58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112256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1FC8FAF-9788-4C13-4D6E-E0B784A964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25F34D01-5E36-A950-5124-3D0CF20C0C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706D551-61B5-5235-97B9-3DD13EF39C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BC52F-5867-487E-8BB6-EC98DC89B367}" type="datetimeFigureOut">
              <a:rPr lang="de-CH" smtClean="0"/>
              <a:t>10.06.2026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1C3FA6E-2ABC-A7F7-0C9A-C7ACF27845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6D996F5-4F03-7D02-1FE3-9E1394E468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9D2DF-16F7-4C7C-B84D-897D9BA3B58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1459946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2C4FD854-DFAC-9C48-3B92-4F4842322F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419F1C7-7E09-EF8B-1A46-7FA62CDA79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BE62387-F55F-9C76-431D-B66F5EDC3C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BC52F-5867-487E-8BB6-EC98DC89B367}" type="datetimeFigureOut">
              <a:rPr lang="de-CH" smtClean="0"/>
              <a:t>10.06.2026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B3669BB-3ACF-3CC7-B9D1-610D4DF02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3787E76-AB12-D1E8-1C43-B7608E74A2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9D2DF-16F7-4C7C-B84D-897D9BA3B58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250343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DA490B6-D3F7-AEDB-962C-25AD04C553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E7B4524-AA5A-C1AB-0D5B-8E205FD65F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1343A6E-D64D-47BB-2E3C-77B438FE84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BC52F-5867-487E-8BB6-EC98DC89B367}" type="datetimeFigureOut">
              <a:rPr lang="de-CH" smtClean="0"/>
              <a:t>10.06.2026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7470293-CF8C-52F9-5C30-E39C7D943F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2F0E8EF-8083-AD03-FBA5-319366F2E1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9D2DF-16F7-4C7C-B84D-897D9BA3B58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771903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7916177-8499-3AFA-1CD7-0826C6E1B9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592B5BFD-F17A-7B12-0FD2-63741871BC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756D6C3-5B8B-DA42-C604-0EC6794176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BC52F-5867-487E-8BB6-EC98DC89B367}" type="datetimeFigureOut">
              <a:rPr lang="de-CH" smtClean="0"/>
              <a:t>10.06.2026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F926E52-8700-FE7D-F29F-2B33D1C8CA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F877485-C65F-F569-3CEB-0724399301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9D2DF-16F7-4C7C-B84D-897D9BA3B58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2797898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9E90FAA-5B40-CAE5-BD31-6414D9B498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5B05795-7241-C46E-7E05-155D5880ABB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61143AB-33AA-080E-A08B-54D2B88B76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19D2C95-5246-1C67-73FC-E10AF9C1AD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BC52F-5867-487E-8BB6-EC98DC89B367}" type="datetimeFigureOut">
              <a:rPr lang="de-CH" smtClean="0"/>
              <a:t>10.06.2026</a:t>
            </a:fld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F8B5BC7-D165-D718-0C80-D2000D4EC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9DC5F36-63C7-23F9-AF06-32E848EF82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9D2DF-16F7-4C7C-B84D-897D9BA3B58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5513386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0A4291B-6E1A-08F9-E428-05E04B2379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12E8F6D-B524-FBBE-C7C9-CA7B975E1B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7D636C6C-CFC5-8B27-A86E-DFB3745F30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915F70B8-1D0A-68F9-A079-F4F0045099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753C0D11-2041-C0BF-E307-9C1D316F2E2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D11CF47F-DE21-7138-A602-DB86EE62E9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BC52F-5867-487E-8BB6-EC98DC89B367}" type="datetimeFigureOut">
              <a:rPr lang="de-CH" smtClean="0"/>
              <a:t>10.06.2026</a:t>
            </a:fld>
            <a:endParaRPr lang="de-CH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D52C13EF-9532-B925-4502-DA73B8E08F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2EE8BF86-7380-1500-BC9C-3A30ABCA3B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9D2DF-16F7-4C7C-B84D-897D9BA3B58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0019450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966171D-0C69-1E99-30F7-E8332B290C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D2ADDEB6-AF28-6B32-8716-A5344E5522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BC52F-5867-487E-8BB6-EC98DC89B367}" type="datetimeFigureOut">
              <a:rPr lang="de-CH" smtClean="0"/>
              <a:t>10.06.2026</a:t>
            </a:fld>
            <a:endParaRPr lang="de-CH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E2CD4B3F-7A60-83A5-ECC5-3C95E10622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6EDAA7D1-1455-D4E0-0661-DB73C7B72E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9D2DF-16F7-4C7C-B84D-897D9BA3B58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69255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1B2783AC-7EF2-04BE-925B-A709D2685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BC52F-5867-487E-8BB6-EC98DC89B367}" type="datetimeFigureOut">
              <a:rPr lang="de-CH" smtClean="0"/>
              <a:t>10.06.2026</a:t>
            </a:fld>
            <a:endParaRPr lang="de-CH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A8450750-65EB-DA80-6F98-670B9552BD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8B1281D4-1C31-A6AB-BB77-D12C46CB5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9D2DF-16F7-4C7C-B84D-897D9BA3B58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999013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4E5B3A0-8B9F-C273-6B6B-6B1BDC9B0C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C23B5B0-9DBA-D681-A2D7-A99F6F2A75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ED3235BA-73B0-8D5E-732B-F3A081BE84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8BCC74E-9FA5-C380-DDD0-A8A4476F9F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BC52F-5867-487E-8BB6-EC98DC89B367}" type="datetimeFigureOut">
              <a:rPr lang="de-CH" smtClean="0"/>
              <a:t>10.06.2026</a:t>
            </a:fld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2C4D379-2D9F-25EF-9D24-A8BE1EE3EE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63CD9DC-E5DA-0B8A-27FC-2D9B77C234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9D2DF-16F7-4C7C-B84D-897D9BA3B58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760098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280070F-B09A-98E2-C3DA-10FD9CB28C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3FBDE40B-D5AF-7BCD-0353-D481746057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DDC050A-2DCE-4BB1-02D3-86EE4B6AC1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834475C-E4FF-B538-F8A3-00E5716B19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BC52F-5867-487E-8BB6-EC98DC89B367}" type="datetimeFigureOut">
              <a:rPr lang="de-CH" smtClean="0"/>
              <a:t>10.06.2026</a:t>
            </a:fld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08AF47C-1C11-33DF-5A49-3EA6F0CC1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ADC4854-88CA-A0C2-E55D-2E612F824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9D2DF-16F7-4C7C-B84D-897D9BA3B58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849990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9688EE08-6331-7838-90C6-12A934C6FD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02A1249-B022-1C76-D41F-EC096210C1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F809BDD-FE43-DC67-DA00-44EA9765D9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DDBC52F-5867-487E-8BB6-EC98DC89B367}" type="datetimeFigureOut">
              <a:rPr lang="de-CH" smtClean="0"/>
              <a:t>10.06.2026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D2B7916-792F-132C-43DE-0019BA025A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167E188-3A71-1D6C-D8C8-2ED1676229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ED9D2DF-16F7-4C7C-B84D-897D9BA3B58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25173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Diagramm 4">
            <a:extLst>
              <a:ext uri="{FF2B5EF4-FFF2-40B4-BE49-F238E27FC236}">
                <a16:creationId xmlns:a16="http://schemas.microsoft.com/office/drawing/2014/main" id="{A291ABCB-1F55-5B04-C541-F337704A51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9917603"/>
              </p:ext>
            </p:extLst>
          </p:nvPr>
        </p:nvGraphicFramePr>
        <p:xfrm>
          <a:off x="6428197" y="734480"/>
          <a:ext cx="4830127" cy="28980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feld 5">
            <a:extLst>
              <a:ext uri="{FF2B5EF4-FFF2-40B4-BE49-F238E27FC236}">
                <a16:creationId xmlns:a16="http://schemas.microsoft.com/office/drawing/2014/main" id="{D68D9B48-1F0E-9CE8-9568-D4204FF810E7}"/>
              </a:ext>
            </a:extLst>
          </p:cNvPr>
          <p:cNvSpPr txBox="1"/>
          <p:nvPr/>
        </p:nvSpPr>
        <p:spPr>
          <a:xfrm>
            <a:off x="91666" y="135974"/>
            <a:ext cx="57838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dirty="0" err="1"/>
              <a:t>Supplementary</a:t>
            </a:r>
            <a:r>
              <a:rPr lang="de-CH" dirty="0"/>
              <a:t> material: Laboratory </a:t>
            </a:r>
            <a:r>
              <a:rPr lang="de-CH" dirty="0" err="1"/>
              <a:t>data</a:t>
            </a:r>
            <a:endParaRPr lang="de-CH" dirty="0"/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8121643D-01E6-931A-3556-39085837EEA7}"/>
              </a:ext>
            </a:extLst>
          </p:cNvPr>
          <p:cNvSpPr txBox="1"/>
          <p:nvPr/>
        </p:nvSpPr>
        <p:spPr>
          <a:xfrm>
            <a:off x="6787586" y="3693379"/>
            <a:ext cx="42141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B: CRP evolution over 28 months. Normal </a:t>
            </a:r>
            <a:r>
              <a:rPr lang="de-CH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nge</a:t>
            </a:r>
            <a:r>
              <a:rPr lang="de-CH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RP &lt; 10mg/l.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5834878C-4A3A-273D-D262-59FA1FCB5424}"/>
              </a:ext>
            </a:extLst>
          </p:cNvPr>
          <p:cNvSpPr txBox="1"/>
          <p:nvPr/>
        </p:nvSpPr>
        <p:spPr>
          <a:xfrm>
            <a:off x="208629" y="682645"/>
            <a:ext cx="351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b="1" dirty="0"/>
              <a:t>A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A7B98BD6-4A33-5A7D-3C8F-AC37582B46CD}"/>
              </a:ext>
            </a:extLst>
          </p:cNvPr>
          <p:cNvSpPr txBox="1"/>
          <p:nvPr/>
        </p:nvSpPr>
        <p:spPr>
          <a:xfrm>
            <a:off x="6026383" y="682645"/>
            <a:ext cx="351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b="1" dirty="0"/>
              <a:t>B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F9A1ABF8-01A0-9FEC-5A40-10257788CE03}"/>
              </a:ext>
            </a:extLst>
          </p:cNvPr>
          <p:cNvSpPr txBox="1"/>
          <p:nvPr/>
        </p:nvSpPr>
        <p:spPr>
          <a:xfrm>
            <a:off x="208629" y="3943704"/>
            <a:ext cx="351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de-CH" b="1" dirty="0"/>
          </a:p>
        </p:txBody>
      </p:sp>
      <p:graphicFrame>
        <p:nvGraphicFramePr>
          <p:cNvPr id="11" name="Diagramm 10">
            <a:extLst>
              <a:ext uri="{FF2B5EF4-FFF2-40B4-BE49-F238E27FC236}">
                <a16:creationId xmlns:a16="http://schemas.microsoft.com/office/drawing/2014/main" id="{7BD3B448-66A8-65AC-42D5-9A63AA8BA81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3610104"/>
              </p:ext>
            </p:extLst>
          </p:nvPr>
        </p:nvGraphicFramePr>
        <p:xfrm>
          <a:off x="720844" y="893253"/>
          <a:ext cx="4683572" cy="28001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Textfeld 11">
            <a:extLst>
              <a:ext uri="{FF2B5EF4-FFF2-40B4-BE49-F238E27FC236}">
                <a16:creationId xmlns:a16="http://schemas.microsoft.com/office/drawing/2014/main" id="{3DD33FB5-F71E-562A-737E-78BD2A7C7C5A}"/>
              </a:ext>
            </a:extLst>
          </p:cNvPr>
          <p:cNvSpPr txBox="1"/>
          <p:nvPr/>
        </p:nvSpPr>
        <p:spPr>
          <a:xfrm>
            <a:off x="641807" y="3693379"/>
            <a:ext cx="48416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A: gGT/AP evolution over 28 months. Normal </a:t>
            </a:r>
            <a:r>
              <a:rPr lang="de-CH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nge</a:t>
            </a:r>
            <a:r>
              <a:rPr lang="de-CH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GT</a:t>
            </a:r>
            <a:r>
              <a:rPr lang="de-CH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12-68 U/l, normal </a:t>
            </a:r>
            <a:r>
              <a:rPr lang="de-CH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nge</a:t>
            </a:r>
            <a:r>
              <a:rPr lang="de-CH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P 40-130 U/l.</a:t>
            </a:r>
          </a:p>
        </p:txBody>
      </p:sp>
    </p:spTree>
    <p:extLst>
      <p:ext uri="{BB962C8B-B14F-4D97-AF65-F5344CB8AC3E}">
        <p14:creationId xmlns:p14="http://schemas.microsoft.com/office/powerpoint/2010/main" val="5816199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5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anne, Isabelle</dc:creator>
  <cp:lastModifiedBy>Megan Bond</cp:lastModifiedBy>
  <cp:revision>2</cp:revision>
  <dcterms:created xsi:type="dcterms:W3CDTF">2026-04-12T12:54:53Z</dcterms:created>
  <dcterms:modified xsi:type="dcterms:W3CDTF">2026-06-10T11:39:51Z</dcterms:modified>
</cp:coreProperties>
</file>